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259F91-69A0-4FCC-AF97-078722EF440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A45BDA-0262-42E2-8DB4-56AE2C8421F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BCF385-51BA-4830-8FF3-8D98F7DA3CB0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0981A-72D1-4472-9A4B-C37E32E6E0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10B00-FEA7-4EFB-B022-A038EFCBC6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15C43-D910-45AE-9E8E-1107568962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820DE-6731-4D16-8E17-300C564CE1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983B9-E661-4645-9B98-2272006D72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92B97-94AA-4602-A1AE-BD98A85B28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08E6C-24D8-4851-9334-68BE9A947F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F37E2-0D01-49A2-A422-5949135A7E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FE17D-E24F-4B6B-89F7-AE4D978EEB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9A0DA-D0F0-4586-95DC-F4F9D193EB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C1BD1-72EF-4A35-9263-1B1116C8C5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218B4-B690-40D0-97C1-DF726352A4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98FA75-90D2-4572-8065-8EF0E2ADC03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C:\Users\ELW\Desktop\Rosemary\TcJA_PI\Sarah_YSL4_TcJA_proto.mdb\New folder\TcJA_PI_1 scale.png"/>
          <p:cNvPicPr/>
          <p:nvPr/>
        </p:nvPicPr>
        <p:blipFill>
          <a:blip r:embed="rId1"/>
          <a:stretch/>
        </p:blipFill>
        <p:spPr>
          <a:xfrm>
            <a:off x="3240000" y="3657600"/>
            <a:ext cx="2813040" cy="28130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C:\Users\ELW\Desktop\Rosemary\TcJA_PI\Sarah_YSL4_TcJA_proto.mdb\New folder\TcJA_PI_2 scale.png"/>
          <p:cNvPicPr/>
          <p:nvPr/>
        </p:nvPicPr>
        <p:blipFill>
          <a:blip r:embed="rId2"/>
          <a:stretch/>
        </p:blipFill>
        <p:spPr>
          <a:xfrm>
            <a:off x="255600" y="3657600"/>
            <a:ext cx="2819520" cy="28195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C:\Users\ELW\Desktop\Rosemary\TcJA_PI\Sarah_YSL4_TcJA_proto.mdb\New folder\TcJA_PI_3 scale.jpg"/>
          <p:cNvPicPr/>
          <p:nvPr/>
        </p:nvPicPr>
        <p:blipFill>
          <a:blip r:embed="rId3"/>
          <a:stretch/>
        </p:blipFill>
        <p:spPr>
          <a:xfrm>
            <a:off x="246240" y="457200"/>
            <a:ext cx="2819160" cy="28195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" descr="C:\Users\ELW\Desktop\Rosemary\TcJA_PI\Sarah_YSL4_TcJA_proto.mdb\New folder\TcJA_PI_4 scale.png"/>
          <p:cNvPicPr/>
          <p:nvPr/>
        </p:nvPicPr>
        <p:blipFill>
          <a:blip r:embed="rId4"/>
          <a:stretch/>
        </p:blipFill>
        <p:spPr>
          <a:xfrm>
            <a:off x="3224160" y="461880"/>
            <a:ext cx="2828880" cy="28288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C:\Users\ELW\Desktop\Rosemary\TcJA_PI\Sarah_YSL4_TcJA_proto.mdb\New folder\TcJA_PI_5 scale.png"/>
          <p:cNvPicPr/>
          <p:nvPr/>
        </p:nvPicPr>
        <p:blipFill>
          <a:blip r:embed="rId5"/>
          <a:stretch/>
        </p:blipFill>
        <p:spPr>
          <a:xfrm>
            <a:off x="6224760" y="447840"/>
            <a:ext cx="2842920" cy="2842920"/>
          </a:xfrm>
          <a:prstGeom prst="rect">
            <a:avLst/>
          </a:prstGeom>
          <a:ln w="0">
            <a:noFill/>
          </a:ln>
        </p:spPr>
      </p:pic>
      <p:sp>
        <p:nvSpPr>
          <p:cNvPr id="53" name="TextBox 8"/>
          <p:cNvSpPr/>
          <p:nvPr/>
        </p:nvSpPr>
        <p:spPr>
          <a:xfrm>
            <a:off x="6224760" y="3962520"/>
            <a:ext cx="291924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CaMV35S</a:t>
            </a: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: TcJAMYC1:sGF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(A)- GFP channel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(B)- Propidium iodide stainin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(C)- Bright fiel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(D)- (A) and (B) merg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(E)- (A),(B) and (C ) merg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"/>
          <p:cNvSpPr/>
          <p:nvPr/>
        </p:nvSpPr>
        <p:spPr>
          <a:xfrm>
            <a:off x="136440" y="168120"/>
            <a:ext cx="6645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A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(B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      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"/>
          <p:cNvSpPr/>
          <p:nvPr/>
        </p:nvSpPr>
        <p:spPr>
          <a:xfrm>
            <a:off x="171360" y="3368520"/>
            <a:ext cx="33764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D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(E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C:\Users\ELW\Desktop\Rosemary\TcJA_PI\Sarah_YSL4_TcJA_proto.mdb\New folder\TcJAMYC_11scale.png"/>
          <p:cNvPicPr/>
          <p:nvPr/>
        </p:nvPicPr>
        <p:blipFill>
          <a:blip r:embed="rId1"/>
          <a:stretch/>
        </p:blipFill>
        <p:spPr>
          <a:xfrm>
            <a:off x="3124080" y="3581280"/>
            <a:ext cx="2895840" cy="28958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3" descr="C:\Users\ELW\Desktop\Rosemary\TcJA_PI\Sarah_YSL4_TcJA_proto.mdb\New folder\TcJAMYC_12 scale.png"/>
          <p:cNvPicPr/>
          <p:nvPr/>
        </p:nvPicPr>
        <p:blipFill>
          <a:blip r:embed="rId2"/>
          <a:stretch/>
        </p:blipFill>
        <p:spPr>
          <a:xfrm>
            <a:off x="76320" y="3581280"/>
            <a:ext cx="2922480" cy="29228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4" descr="C:\Users\ELW\Desktop\Rosemary\TcJA_PI\Sarah_YSL4_TcJA_proto.mdb\New folder\TcJAMYC_13 scale.png"/>
          <p:cNvPicPr/>
          <p:nvPr/>
        </p:nvPicPr>
        <p:blipFill>
          <a:blip r:embed="rId3"/>
          <a:stretch/>
        </p:blipFill>
        <p:spPr>
          <a:xfrm>
            <a:off x="76320" y="289080"/>
            <a:ext cx="2911320" cy="29113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5" descr="C:\Users\ELW\Desktop\Rosemary\TcJA_PI\Sarah_YSL4_TcJA_proto.mdb\New folder\TcJAMYC_14 scale.png"/>
          <p:cNvPicPr/>
          <p:nvPr/>
        </p:nvPicPr>
        <p:blipFill>
          <a:blip r:embed="rId4"/>
          <a:stretch/>
        </p:blipFill>
        <p:spPr>
          <a:xfrm>
            <a:off x="3108240" y="304920"/>
            <a:ext cx="2911680" cy="29113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6" descr="C:\Users\ELW\Desktop\Rosemary\TcJA_PI\Sarah_YSL4_TcJA_proto.mdb\New folder\TcJAMYC_15 scale.png"/>
          <p:cNvPicPr/>
          <p:nvPr/>
        </p:nvPicPr>
        <p:blipFill>
          <a:blip r:embed="rId5"/>
          <a:stretch/>
        </p:blipFill>
        <p:spPr>
          <a:xfrm>
            <a:off x="6095880" y="304920"/>
            <a:ext cx="2911680" cy="2911320"/>
          </a:xfrm>
          <a:prstGeom prst="rect">
            <a:avLst/>
          </a:prstGeom>
          <a:ln w="0">
            <a:noFill/>
          </a:ln>
        </p:spPr>
      </p:pic>
      <p:sp>
        <p:nvSpPr>
          <p:cNvPr id="61" name="TextBox 3"/>
          <p:cNvSpPr/>
          <p:nvPr/>
        </p:nvSpPr>
        <p:spPr>
          <a:xfrm>
            <a:off x="6156360" y="3886200"/>
            <a:ext cx="2987640" cy="204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CaMV35S</a:t>
            </a:r>
            <a:r>
              <a:rPr b="1" i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: TcJAMYC1:sGF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F- GFP channel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G- Chlorophyll auto fluorescenc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H- Bright fiel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I- (F) and (G) merg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Arial"/>
              </a:rPr>
              <a:t>J- (F),(G) and (H ) merg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3"/>
          <p:cNvSpPr/>
          <p:nvPr/>
        </p:nvSpPr>
        <p:spPr>
          <a:xfrm>
            <a:off x="-12600" y="0"/>
            <a:ext cx="66434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F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 (G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       (H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4"/>
          <p:cNvSpPr/>
          <p:nvPr/>
        </p:nvSpPr>
        <p:spPr>
          <a:xfrm>
            <a:off x="58320" y="3287880"/>
            <a:ext cx="3390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I)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     (J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1T00:10:01Z</dcterms:created>
  <dc:creator>ELW</dc:creator>
  <dc:description/>
  <dc:language>en-US</dc:language>
  <cp:lastModifiedBy>OMM</cp:lastModifiedBy>
  <dcterms:modified xsi:type="dcterms:W3CDTF">2014-12-25T22:10:26Z</dcterms:modified>
  <cp:revision>1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